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A6C7D-0211-4E3C-9920-7C63ED32D0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54600-1F02-4D01-9E01-4C140D7330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BF52B-0A93-4F9E-A2F2-48C5DAFEB1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CFA0E-E5E4-43AF-AF27-80EECBC4A0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4475C-EC52-4308-B7E7-FDB216E652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34900-D166-420A-8774-B4F292553F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6D730-C10E-42F7-91A8-C9C12EC8D7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EF6E9-A5BD-4B3E-BF8B-ECEA64D866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6D9F9-271D-49A6-8DFB-FCA766A61D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8BD38-AC06-4C29-9A09-3345E92E29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88CCB-7BFF-465B-B3FF-F727718BB2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FFD4D-DEA0-46CA-93B4-E9389E6117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1D64F5-67F2-42AB-934D-870C236FCA1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"/>
          <p:cNvSpPr/>
          <p:nvPr/>
        </p:nvSpPr>
        <p:spPr>
          <a:xfrm>
            <a:off x="3494160" y="1366920"/>
            <a:ext cx="106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ffffff"/>
                </a:solidFill>
                <a:latin typeface="Times New Roman"/>
              </a:rPr>
              <a:t>Hb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8"/>
          <p:cNvSpPr/>
          <p:nvPr/>
        </p:nvSpPr>
        <p:spPr>
          <a:xfrm>
            <a:off x="4373640" y="1930320"/>
            <a:ext cx="1279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HbF(11.6%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"/>
          <p:cNvSpPr/>
          <p:nvPr/>
        </p:nvSpPr>
        <p:spPr>
          <a:xfrm>
            <a:off x="241200" y="270000"/>
            <a:ext cx="3610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le 1 (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3" descr="190701219洪"/>
          <p:cNvPicPr/>
          <p:nvPr/>
        </p:nvPicPr>
        <p:blipFill>
          <a:blip r:embed="rId1"/>
          <a:stretch/>
        </p:blipFill>
        <p:spPr>
          <a:xfrm>
            <a:off x="544680" y="1128600"/>
            <a:ext cx="8151480" cy="5330880"/>
          </a:xfrm>
          <a:prstGeom prst="rect">
            <a:avLst/>
          </a:prstGeom>
          <a:ln w="0">
            <a:noFill/>
          </a:ln>
        </p:spPr>
      </p:pic>
      <p:sp>
        <p:nvSpPr>
          <p:cNvPr id="45" name="Text Box 14"/>
          <p:cNvSpPr/>
          <p:nvPr/>
        </p:nvSpPr>
        <p:spPr>
          <a:xfrm>
            <a:off x="1982880" y="2273400"/>
            <a:ext cx="1454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imes New Roman"/>
              </a:rPr>
              <a:t>HbA:77.8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5"/>
          <p:cNvSpPr/>
          <p:nvPr/>
        </p:nvSpPr>
        <p:spPr>
          <a:xfrm>
            <a:off x="4095720" y="4240080"/>
            <a:ext cx="1454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imes New Roman"/>
              </a:rPr>
              <a:t>HbF:11.3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6"/>
          <p:cNvSpPr/>
          <p:nvPr/>
        </p:nvSpPr>
        <p:spPr>
          <a:xfrm>
            <a:off x="5111640" y="4637160"/>
            <a:ext cx="1454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imes New Roman"/>
              </a:rPr>
              <a:t>Z6:8.6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7"/>
          <p:cNvSpPr/>
          <p:nvPr/>
        </p:nvSpPr>
        <p:spPr>
          <a:xfrm>
            <a:off x="6308640" y="5200560"/>
            <a:ext cx="1454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imes New Roman"/>
              </a:rPr>
              <a:t>HbA2:2.3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 Box 3"/>
          <p:cNvSpPr/>
          <p:nvPr/>
        </p:nvSpPr>
        <p:spPr>
          <a:xfrm>
            <a:off x="241200" y="270000"/>
            <a:ext cx="4395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le 1 (B)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0" y="1085760"/>
            <a:ext cx="9042480" cy="511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 Box 5"/>
          <p:cNvSpPr/>
          <p:nvPr/>
        </p:nvSpPr>
        <p:spPr>
          <a:xfrm>
            <a:off x="146160" y="154080"/>
            <a:ext cx="3363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le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"/>
          <p:cNvGrpSpPr/>
          <p:nvPr/>
        </p:nvGrpSpPr>
        <p:grpSpPr>
          <a:xfrm>
            <a:off x="801720" y="743040"/>
            <a:ext cx="6415200" cy="5965560"/>
            <a:chOff x="801720" y="743040"/>
            <a:chExt cx="6415200" cy="5965560"/>
          </a:xfrm>
        </p:grpSpPr>
        <p:sp>
          <p:nvSpPr>
            <p:cNvPr id="53" name="Text Box 6"/>
            <p:cNvSpPr/>
            <p:nvPr/>
          </p:nvSpPr>
          <p:spPr>
            <a:xfrm>
              <a:off x="3108240" y="743040"/>
              <a:ext cx="3889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Times New Roman"/>
                </a:rPr>
                <a:t>     </a:t>
              </a:r>
              <a:r>
                <a:rPr b="0" lang="zh-CN" sz="1800" spc="-1" strike="noStrike">
                  <a:solidFill>
                    <a:srgbClr val="000000"/>
                  </a:solidFill>
                  <a:latin typeface="Times New Roman"/>
                </a:rPr>
                <a:t>M      Patient  Normal  Norma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4" name=""/>
            <p:cNvGrpSpPr/>
            <p:nvPr/>
          </p:nvGrpSpPr>
          <p:grpSpPr>
            <a:xfrm>
              <a:off x="1692360" y="1120680"/>
              <a:ext cx="5524560" cy="5587920"/>
              <a:chOff x="1692360" y="1120680"/>
              <a:chExt cx="5524560" cy="5587920"/>
            </a:xfrm>
          </p:grpSpPr>
          <p:pic>
            <p:nvPicPr>
              <p:cNvPr id="55" name="Picture 4" descr="洪电泳图"/>
              <p:cNvPicPr/>
              <p:nvPr/>
            </p:nvPicPr>
            <p:blipFill>
              <a:blip r:embed="rId1"/>
              <a:stretch/>
            </p:blipFill>
            <p:spPr>
              <a:xfrm>
                <a:off x="2897280" y="1120680"/>
                <a:ext cx="4319640" cy="5587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Line 7"/>
              <p:cNvSpPr/>
              <p:nvPr/>
            </p:nvSpPr>
            <p:spPr>
              <a:xfrm>
                <a:off x="2522520" y="3313080"/>
                <a:ext cx="1461960" cy="604800"/>
              </a:xfrm>
              <a:prstGeom prst="line">
                <a:avLst/>
              </a:prstGeom>
              <a:ln w="15840">
                <a:solidFill>
                  <a:srgbClr val="ff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8"/>
              <p:cNvSpPr/>
              <p:nvPr/>
            </p:nvSpPr>
            <p:spPr>
              <a:xfrm>
                <a:off x="1692360" y="3022560"/>
                <a:ext cx="1058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915bp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9"/>
              <p:cNvSpPr/>
              <p:nvPr/>
            </p:nvSpPr>
            <p:spPr>
              <a:xfrm flipV="1">
                <a:off x="1876320" y="4216320"/>
                <a:ext cx="2214720" cy="230400"/>
              </a:xfrm>
              <a:prstGeom prst="line">
                <a:avLst/>
              </a:prstGeom>
              <a:ln w="15840">
                <a:solidFill>
                  <a:srgbClr val="ff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Text Box 10"/>
            <p:cNvSpPr/>
            <p:nvPr/>
          </p:nvSpPr>
          <p:spPr>
            <a:xfrm>
              <a:off x="801720" y="4230720"/>
              <a:ext cx="105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775bp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1-07T03:14:57Z</dcterms:created>
  <dc:creator>Think</dc:creator>
  <dc:description/>
  <dc:language>en-US</dc:language>
  <cp:lastModifiedBy>Think</cp:lastModifiedBy>
  <dcterms:modified xsi:type="dcterms:W3CDTF">2019-11-09T04:16:25Z</dcterms:modified>
  <cp:revision>3</cp:revision>
  <dc:subject/>
  <dc:title>幻灯片 1</dc:title>
</cp:coreProperties>
</file>